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 showGuides="1">
      <p:cViewPr varScale="1">
        <p:scale>
          <a:sx n="67" d="100"/>
          <a:sy n="67" d="100"/>
        </p:scale>
        <p:origin x="-11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33955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708422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555445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31085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244696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843870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40675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000053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92661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51430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429333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B55D4-A660-427A-A973-EB04637D6FB3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59D8C-F41F-4740-9F8A-33D0C16C3A3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84550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2123728" y="836712"/>
            <a:ext cx="1368080" cy="1006378"/>
            <a:chOff x="2123728" y="1814627"/>
            <a:chExt cx="1368080" cy="1006378"/>
          </a:xfrm>
        </p:grpSpPr>
        <p:sp>
          <p:nvSpPr>
            <p:cNvPr id="4" name="TextBox 3"/>
            <p:cNvSpPr txBox="1"/>
            <p:nvPr/>
          </p:nvSpPr>
          <p:spPr>
            <a:xfrm rot="16200000">
              <a:off x="2147232" y="2505373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QuadreDeText 7"/>
            <p:cNvSpPr txBox="1"/>
            <p:nvPr/>
          </p:nvSpPr>
          <p:spPr>
            <a:xfrm rot="16200000">
              <a:off x="2426859" y="2445866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P8</a:t>
              </a:r>
              <a:endParaRPr lang="ca-E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2815169" y="2505373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QuadreDeText 7"/>
            <p:cNvSpPr txBox="1"/>
            <p:nvPr/>
          </p:nvSpPr>
          <p:spPr>
            <a:xfrm rot="16200000">
              <a:off x="3094796" y="2445866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P8</a:t>
              </a:r>
              <a:endParaRPr lang="ca-E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2123728" y="2348880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2843808" y="2348880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"/>
            <p:cNvSpPr txBox="1"/>
            <p:nvPr/>
          </p:nvSpPr>
          <p:spPr>
            <a:xfrm>
              <a:off x="2282946" y="1814627"/>
              <a:ext cx="11144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X (100 </a:t>
              </a:r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/>
                </a:rPr>
                <a:t></a:t>
              </a:r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/ml)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"/>
            <p:cNvSpPr txBox="1"/>
            <p:nvPr/>
          </p:nvSpPr>
          <p:spPr>
            <a:xfrm>
              <a:off x="2289262" y="2102659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h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"/>
            <p:cNvSpPr txBox="1"/>
            <p:nvPr/>
          </p:nvSpPr>
          <p:spPr>
            <a:xfrm>
              <a:off x="2971438" y="2102659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2123728" y="2060848"/>
              <a:ext cx="1368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Box 1"/>
          <p:cNvSpPr txBox="1"/>
          <p:nvPr/>
        </p:nvSpPr>
        <p:spPr>
          <a:xfrm>
            <a:off x="3565601" y="2898438"/>
            <a:ext cx="10214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XK1</a:t>
            </a:r>
            <a:r>
              <a:rPr lang="es-E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4.8, 3.8)</a:t>
            </a:r>
            <a:endParaRPr lang="es-ES_tradnl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2116990" y="2871257"/>
            <a:ext cx="1458196" cy="303278"/>
            <a:chOff x="2115277" y="3155598"/>
            <a:chExt cx="1458196" cy="303278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15277" y="3157811"/>
              <a:ext cx="1449745" cy="3010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Rectangle 27"/>
            <p:cNvSpPr/>
            <p:nvPr/>
          </p:nvSpPr>
          <p:spPr>
            <a:xfrm>
              <a:off x="2123728" y="3155598"/>
              <a:ext cx="1449745" cy="30106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2114142" y="1789980"/>
            <a:ext cx="2464767" cy="301065"/>
            <a:chOff x="2114142" y="2767895"/>
            <a:chExt cx="2464767" cy="301065"/>
          </a:xfrm>
        </p:grpSpPr>
        <p:sp>
          <p:nvSpPr>
            <p:cNvPr id="26" name="TextBox 1"/>
            <p:cNvSpPr txBox="1"/>
            <p:nvPr/>
          </p:nvSpPr>
          <p:spPr>
            <a:xfrm>
              <a:off x="3563888" y="2792804"/>
              <a:ext cx="10150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XT2 </a:t>
              </a:r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9.1, 7.4)</a:t>
              </a:r>
              <a:endParaRPr lang="es-ES_tradnl" sz="10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26" r="3941" b="11412"/>
            <a:stretch/>
          </p:blipFill>
          <p:spPr bwMode="auto">
            <a:xfrm>
              <a:off x="2114142" y="2777568"/>
              <a:ext cx="1459331" cy="2913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6" name="Rectangle 35"/>
            <p:cNvSpPr/>
            <p:nvPr/>
          </p:nvSpPr>
          <p:spPr>
            <a:xfrm>
              <a:off x="2123728" y="2767895"/>
              <a:ext cx="1449745" cy="30106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</p:grpSp>
      <p:sp>
        <p:nvSpPr>
          <p:cNvPr id="33" name="TextBox 1"/>
          <p:cNvSpPr txBox="1"/>
          <p:nvPr/>
        </p:nvSpPr>
        <p:spPr>
          <a:xfrm>
            <a:off x="7427332" y="2936311"/>
            <a:ext cx="10647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P26</a:t>
            </a:r>
            <a:r>
              <a:rPr lang="es-E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6.1, 7.5)</a:t>
            </a:r>
            <a:endParaRPr lang="es-ES_tradnl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5965146" y="2919802"/>
            <a:ext cx="1459331" cy="316924"/>
            <a:chOff x="2118223" y="4352071"/>
            <a:chExt cx="1459331" cy="316924"/>
          </a:xfrm>
        </p:grpSpPr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90" t="19301" r="7378"/>
            <a:stretch/>
          </p:blipFill>
          <p:spPr bwMode="auto">
            <a:xfrm>
              <a:off x="2118223" y="4367930"/>
              <a:ext cx="1459331" cy="3010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7" name="Rectangle 36"/>
            <p:cNvSpPr/>
            <p:nvPr/>
          </p:nvSpPr>
          <p:spPr>
            <a:xfrm>
              <a:off x="2123266" y="4352071"/>
              <a:ext cx="1449745" cy="30106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</p:grpSp>
      <p:sp>
        <p:nvSpPr>
          <p:cNvPr id="41" name="TextBox 1"/>
          <p:cNvSpPr txBox="1"/>
          <p:nvPr/>
        </p:nvSpPr>
        <p:spPr>
          <a:xfrm>
            <a:off x="7441039" y="3837043"/>
            <a:ext cx="10086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B2</a:t>
            </a:r>
            <a:r>
              <a:rPr lang="es-E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.0, 0.7)</a:t>
            </a:r>
            <a:endParaRPr lang="es-ES_tradnl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1"/>
          <p:cNvSpPr txBox="1"/>
          <p:nvPr/>
        </p:nvSpPr>
        <p:spPr>
          <a:xfrm>
            <a:off x="7427523" y="2588899"/>
            <a:ext cx="11897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P12</a:t>
            </a:r>
            <a:r>
              <a:rPr lang="es-E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/D, 52.7)</a:t>
            </a:r>
            <a:endParaRPr lang="es-ES_tradnl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0" name="Group 39"/>
          <p:cNvGrpSpPr/>
          <p:nvPr/>
        </p:nvGrpSpPr>
        <p:grpSpPr>
          <a:xfrm>
            <a:off x="2123728" y="2509900"/>
            <a:ext cx="2498463" cy="301225"/>
            <a:chOff x="2123728" y="3573016"/>
            <a:chExt cx="2498463" cy="301225"/>
          </a:xfrm>
        </p:grpSpPr>
        <p:sp>
          <p:nvSpPr>
            <p:cNvPr id="53" name="TextBox 1"/>
            <p:cNvSpPr txBox="1"/>
            <p:nvPr/>
          </p:nvSpPr>
          <p:spPr>
            <a:xfrm>
              <a:off x="3563888" y="3608477"/>
              <a:ext cx="10583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H2</a:t>
              </a:r>
              <a:r>
                <a:rPr lang="es-ES" sz="1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3.5, 3.7)</a:t>
              </a:r>
              <a:endParaRPr lang="es-ES_tradnl" sz="10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2123728" y="3573016"/>
              <a:ext cx="1451031" cy="301225"/>
              <a:chOff x="5218786" y="3559823"/>
              <a:chExt cx="1451031" cy="301225"/>
            </a:xfrm>
          </p:grpSpPr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18786" y="3559823"/>
                <a:ext cx="1449745" cy="3010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4" name="Rectangle 53"/>
              <p:cNvSpPr/>
              <p:nvPr/>
            </p:nvSpPr>
            <p:spPr>
              <a:xfrm>
                <a:off x="5220072" y="3559983"/>
                <a:ext cx="1449745" cy="301065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</p:grpSp>
      </p:grpSp>
      <p:grpSp>
        <p:nvGrpSpPr>
          <p:cNvPr id="39" name="Group 38"/>
          <p:cNvGrpSpPr/>
          <p:nvPr/>
        </p:nvGrpSpPr>
        <p:grpSpPr>
          <a:xfrm>
            <a:off x="2125717" y="2135255"/>
            <a:ext cx="2453192" cy="328530"/>
            <a:chOff x="2125717" y="3172478"/>
            <a:chExt cx="2453192" cy="328530"/>
          </a:xfrm>
        </p:grpSpPr>
        <p:sp>
          <p:nvSpPr>
            <p:cNvPr id="51" name="TextBox 1"/>
            <p:cNvSpPr txBox="1"/>
            <p:nvPr/>
          </p:nvSpPr>
          <p:spPr>
            <a:xfrm>
              <a:off x="3563888" y="3212224"/>
              <a:ext cx="10150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XT7</a:t>
              </a:r>
              <a:r>
                <a:rPr lang="es-ES" sz="1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4.4, 2.3)</a:t>
              </a:r>
              <a:endParaRPr lang="es-ES_tradnl" sz="10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5" name="Group 44"/>
            <p:cNvGrpSpPr/>
            <p:nvPr/>
          </p:nvGrpSpPr>
          <p:grpSpPr>
            <a:xfrm>
              <a:off x="2125717" y="3172478"/>
              <a:ext cx="1455701" cy="328530"/>
              <a:chOff x="5220072" y="3188065"/>
              <a:chExt cx="1455701" cy="328530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983"/>
              <a:stretch/>
            </p:blipFill>
            <p:spPr bwMode="auto">
              <a:xfrm>
                <a:off x="5220072" y="3188065"/>
                <a:ext cx="1455701" cy="3285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2" name="Rectangle 51"/>
              <p:cNvSpPr/>
              <p:nvPr/>
            </p:nvSpPr>
            <p:spPr>
              <a:xfrm>
                <a:off x="5220396" y="3199943"/>
                <a:ext cx="1449745" cy="301065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</p:grpSp>
      </p:grpSp>
      <p:grpSp>
        <p:nvGrpSpPr>
          <p:cNvPr id="62" name="Group 61"/>
          <p:cNvGrpSpPr/>
          <p:nvPr/>
        </p:nvGrpSpPr>
        <p:grpSpPr>
          <a:xfrm>
            <a:off x="5960526" y="2563745"/>
            <a:ext cx="1461686" cy="301065"/>
            <a:chOff x="5198546" y="4640103"/>
            <a:chExt cx="1461686" cy="301065"/>
          </a:xfrm>
        </p:grpSpPr>
        <p:pic>
          <p:nvPicPr>
            <p:cNvPr id="1032" name="Picture 8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44" r="4496" b="12555"/>
            <a:stretch/>
          </p:blipFill>
          <p:spPr bwMode="auto">
            <a:xfrm>
              <a:off x="5198546" y="4650310"/>
              <a:ext cx="1461686" cy="2908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0" name="Rectangle 59"/>
            <p:cNvSpPr/>
            <p:nvPr/>
          </p:nvSpPr>
          <p:spPr>
            <a:xfrm>
              <a:off x="5210487" y="4640103"/>
              <a:ext cx="1449745" cy="30106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</p:grpSp>
      <p:sp>
        <p:nvSpPr>
          <p:cNvPr id="64" name="TextBox 1"/>
          <p:cNvSpPr txBox="1"/>
          <p:nvPr/>
        </p:nvSpPr>
        <p:spPr>
          <a:xfrm>
            <a:off x="7431046" y="3391962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1</a:t>
            </a:r>
            <a:r>
              <a:rPr lang="es-E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/D, 95)</a:t>
            </a:r>
            <a:endParaRPr lang="es-ES_tradnl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8" name="Group 47"/>
          <p:cNvGrpSpPr/>
          <p:nvPr/>
        </p:nvGrpSpPr>
        <p:grpSpPr>
          <a:xfrm>
            <a:off x="5953282" y="3812790"/>
            <a:ext cx="1475059" cy="301065"/>
            <a:chOff x="4893764" y="5580791"/>
            <a:chExt cx="1475059" cy="301065"/>
          </a:xfrm>
        </p:grpSpPr>
        <p:pic>
          <p:nvPicPr>
            <p:cNvPr id="34" name="Picture 6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060" t="24645" r="6568" b="31417"/>
            <a:stretch/>
          </p:blipFill>
          <p:spPr bwMode="auto">
            <a:xfrm>
              <a:off x="4893764" y="5585666"/>
              <a:ext cx="1475059" cy="2961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1" name="Rectangle 80"/>
            <p:cNvSpPr/>
            <p:nvPr/>
          </p:nvSpPr>
          <p:spPr>
            <a:xfrm>
              <a:off x="4919078" y="5580791"/>
              <a:ext cx="1449745" cy="30106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</p:grpSp>
      <p:sp>
        <p:nvSpPr>
          <p:cNvPr id="25" name="Rectangle 24"/>
          <p:cNvSpPr/>
          <p:nvPr/>
        </p:nvSpPr>
        <p:spPr>
          <a:xfrm>
            <a:off x="1018208" y="2253700"/>
            <a:ext cx="102463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bohydrate</a:t>
            </a:r>
          </a:p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sm</a:t>
            </a:r>
            <a:endParaRPr lang="es-ES_trad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2051720" y="1781601"/>
            <a:ext cx="0" cy="13895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2" name="Group 81"/>
          <p:cNvGrpSpPr/>
          <p:nvPr/>
        </p:nvGrpSpPr>
        <p:grpSpPr>
          <a:xfrm>
            <a:off x="1062658" y="3409095"/>
            <a:ext cx="3511500" cy="684000"/>
            <a:chOff x="1062658" y="4065852"/>
            <a:chExt cx="3511500" cy="684000"/>
          </a:xfrm>
        </p:grpSpPr>
        <p:grpSp>
          <p:nvGrpSpPr>
            <p:cNvPr id="44" name="Group 43"/>
            <p:cNvGrpSpPr/>
            <p:nvPr/>
          </p:nvGrpSpPr>
          <p:grpSpPr>
            <a:xfrm>
              <a:off x="2125576" y="4430429"/>
              <a:ext cx="2434156" cy="301065"/>
              <a:chOff x="2123915" y="4568095"/>
              <a:chExt cx="2434156" cy="301065"/>
            </a:xfrm>
          </p:grpSpPr>
          <p:sp>
            <p:nvSpPr>
              <p:cNvPr id="21" name="TextBox 1"/>
              <p:cNvSpPr txBox="1"/>
              <p:nvPr/>
            </p:nvSpPr>
            <p:spPr>
              <a:xfrm>
                <a:off x="3563888" y="4596986"/>
                <a:ext cx="99418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Y1</a:t>
                </a:r>
                <a:r>
                  <a:rPr lang="es-ES" sz="10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5.3, 4.1)</a:t>
                </a:r>
                <a:endParaRPr lang="es-ES_tradnl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9" name="Group 18"/>
              <p:cNvGrpSpPr/>
              <p:nvPr/>
            </p:nvGrpSpPr>
            <p:grpSpPr>
              <a:xfrm>
                <a:off x="2123915" y="4568095"/>
                <a:ext cx="1454044" cy="301065"/>
                <a:chOff x="2114143" y="2780928"/>
                <a:chExt cx="1454044" cy="301065"/>
              </a:xfrm>
            </p:grpSpPr>
            <p:pic>
              <p:nvPicPr>
                <p:cNvPr id="1026" name="Picture 2"/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118442" y="2780928"/>
                  <a:ext cx="1449745" cy="3010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0" name="Rectangle 19"/>
                <p:cNvSpPr/>
                <p:nvPr/>
              </p:nvSpPr>
              <p:spPr>
                <a:xfrm>
                  <a:off x="2114143" y="2780928"/>
                  <a:ext cx="1449745" cy="301065"/>
                </a:xfrm>
                <a:prstGeom prst="rect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_tradnl"/>
                </a:p>
              </p:txBody>
            </p:sp>
          </p:grpSp>
        </p:grpSp>
        <p:grpSp>
          <p:nvGrpSpPr>
            <p:cNvPr id="42" name="Group 41"/>
            <p:cNvGrpSpPr/>
            <p:nvPr/>
          </p:nvGrpSpPr>
          <p:grpSpPr>
            <a:xfrm>
              <a:off x="2115460" y="4077072"/>
              <a:ext cx="2458698" cy="313200"/>
              <a:chOff x="2113799" y="4123912"/>
              <a:chExt cx="2458698" cy="313200"/>
            </a:xfrm>
          </p:grpSpPr>
          <p:sp>
            <p:nvSpPr>
              <p:cNvPr id="68" name="TextBox 1"/>
              <p:cNvSpPr txBox="1"/>
              <p:nvPr/>
            </p:nvSpPr>
            <p:spPr>
              <a:xfrm>
                <a:off x="3563888" y="4144283"/>
                <a:ext cx="100860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C1</a:t>
                </a:r>
                <a:r>
                  <a:rPr lang="es-ES" sz="10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.9, 3.5)</a:t>
                </a:r>
                <a:endPara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3" name="Group 22"/>
              <p:cNvGrpSpPr/>
              <p:nvPr/>
            </p:nvGrpSpPr>
            <p:grpSpPr>
              <a:xfrm>
                <a:off x="2113799" y="4123912"/>
                <a:ext cx="1474732" cy="313200"/>
                <a:chOff x="2120149" y="3501008"/>
                <a:chExt cx="1474732" cy="313200"/>
              </a:xfrm>
            </p:grpSpPr>
            <p:pic>
              <p:nvPicPr>
                <p:cNvPr id="5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40" t="17203" r="3702" b="20063"/>
                <a:stretch/>
              </p:blipFill>
              <p:spPr bwMode="auto">
                <a:xfrm>
                  <a:off x="2120149" y="3513143"/>
                  <a:ext cx="1474732" cy="3010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2" name="Rectangle 71"/>
                <p:cNvSpPr/>
                <p:nvPr/>
              </p:nvSpPr>
              <p:spPr>
                <a:xfrm>
                  <a:off x="2132025" y="3501008"/>
                  <a:ext cx="1449745" cy="301065"/>
                </a:xfrm>
                <a:prstGeom prst="rect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_tradnl"/>
                </a:p>
              </p:txBody>
            </p:sp>
          </p:grpSp>
        </p:grpSp>
        <p:sp>
          <p:nvSpPr>
            <p:cNvPr id="65" name="Rectangle 64"/>
            <p:cNvSpPr/>
            <p:nvPr/>
          </p:nvSpPr>
          <p:spPr>
            <a:xfrm>
              <a:off x="1062658" y="4176704"/>
              <a:ext cx="98456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ogen</a:t>
              </a:r>
            </a:p>
            <a:p>
              <a:pPr algn="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sis </a:t>
              </a:r>
              <a:endParaRPr lang="es-ES_tradn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4" name="Straight Connector 73"/>
            <p:cNvCxnSpPr/>
            <p:nvPr/>
          </p:nvCxnSpPr>
          <p:spPr>
            <a:xfrm>
              <a:off x="2051720" y="4065852"/>
              <a:ext cx="0" cy="684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oup 79"/>
          <p:cNvGrpSpPr/>
          <p:nvPr/>
        </p:nvGrpSpPr>
        <p:grpSpPr>
          <a:xfrm>
            <a:off x="618870" y="4212403"/>
            <a:ext cx="4025763" cy="686954"/>
            <a:chOff x="618870" y="4981951"/>
            <a:chExt cx="4025763" cy="686954"/>
          </a:xfrm>
        </p:grpSpPr>
        <p:grpSp>
          <p:nvGrpSpPr>
            <p:cNvPr id="49" name="Group 48"/>
            <p:cNvGrpSpPr/>
            <p:nvPr/>
          </p:nvGrpSpPr>
          <p:grpSpPr>
            <a:xfrm>
              <a:off x="2112773" y="5360183"/>
              <a:ext cx="2531860" cy="301065"/>
              <a:chOff x="2112773" y="5432191"/>
              <a:chExt cx="2531860" cy="301065"/>
            </a:xfrm>
          </p:grpSpPr>
          <p:sp>
            <p:nvSpPr>
              <p:cNvPr id="55" name="TextBox 1"/>
              <p:cNvSpPr txBox="1"/>
              <p:nvPr/>
            </p:nvSpPr>
            <p:spPr>
              <a:xfrm>
                <a:off x="3563888" y="5451574"/>
                <a:ext cx="108074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84 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.3, 0.1)</a:t>
                </a:r>
                <a:endPara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7" name="Group 26"/>
              <p:cNvGrpSpPr/>
              <p:nvPr/>
            </p:nvGrpSpPr>
            <p:grpSpPr>
              <a:xfrm>
                <a:off x="2112773" y="5432191"/>
                <a:ext cx="1465200" cy="301065"/>
                <a:chOff x="5217238" y="3422483"/>
                <a:chExt cx="1458548" cy="301065"/>
              </a:xfrm>
            </p:grpSpPr>
            <p:pic>
              <p:nvPicPr>
                <p:cNvPr id="46" name="Picture 9"/>
                <p:cNvPicPr>
                  <a:picLocks noChangeAspect="1" noChangeArrowheads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103" t="19781" r="1754" b="18414"/>
                <a:stretch/>
              </p:blipFill>
              <p:spPr bwMode="auto">
                <a:xfrm>
                  <a:off x="5217238" y="3428999"/>
                  <a:ext cx="1444634" cy="2945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56" name="Rectangle 55"/>
                <p:cNvSpPr/>
                <p:nvPr/>
              </p:nvSpPr>
              <p:spPr>
                <a:xfrm>
                  <a:off x="5226041" y="3422483"/>
                  <a:ext cx="1449745" cy="301065"/>
                </a:xfrm>
                <a:prstGeom prst="rect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_tradnl"/>
                </a:p>
              </p:txBody>
            </p:sp>
          </p:grpSp>
        </p:grpSp>
        <p:grpSp>
          <p:nvGrpSpPr>
            <p:cNvPr id="47" name="Group 46"/>
            <p:cNvGrpSpPr/>
            <p:nvPr/>
          </p:nvGrpSpPr>
          <p:grpSpPr>
            <a:xfrm>
              <a:off x="2123962" y="4988425"/>
              <a:ext cx="2454947" cy="312783"/>
              <a:chOff x="2123962" y="4988425"/>
              <a:chExt cx="2454947" cy="312783"/>
            </a:xfrm>
          </p:grpSpPr>
          <p:sp>
            <p:nvSpPr>
              <p:cNvPr id="57" name="TextBox 1"/>
              <p:cNvSpPr txBox="1"/>
              <p:nvPr/>
            </p:nvSpPr>
            <p:spPr>
              <a:xfrm>
                <a:off x="3563888" y="5020491"/>
                <a:ext cx="10150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N1</a:t>
                </a:r>
                <a:r>
                  <a:rPr lang="es-ES" sz="10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.4, 0.2)</a:t>
                </a:r>
                <a:endPara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1" name="Group 60"/>
              <p:cNvGrpSpPr/>
              <p:nvPr/>
            </p:nvGrpSpPr>
            <p:grpSpPr>
              <a:xfrm>
                <a:off x="2123962" y="4988425"/>
                <a:ext cx="1466368" cy="312783"/>
                <a:chOff x="5220072" y="4268345"/>
                <a:chExt cx="1466368" cy="312783"/>
              </a:xfrm>
            </p:grpSpPr>
            <p:pic>
              <p:nvPicPr>
                <p:cNvPr id="1031" name="Picture 7"/>
                <p:cNvPicPr>
                  <a:picLocks noChangeAspect="1" noChangeArrowheads="1"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383" r="4170" b="9299"/>
                <a:stretch/>
              </p:blipFill>
              <p:spPr bwMode="auto">
                <a:xfrm>
                  <a:off x="5224755" y="4268345"/>
                  <a:ext cx="1461685" cy="3010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58" name="Rectangle 57"/>
                <p:cNvSpPr/>
                <p:nvPr/>
              </p:nvSpPr>
              <p:spPr>
                <a:xfrm>
                  <a:off x="5220072" y="4280063"/>
                  <a:ext cx="1449745" cy="301065"/>
                </a:xfrm>
                <a:prstGeom prst="rect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_tradnl"/>
                </a:p>
              </p:txBody>
            </p:sp>
          </p:grpSp>
        </p:grpSp>
        <p:sp>
          <p:nvSpPr>
            <p:cNvPr id="66" name="Rectangle 65"/>
            <p:cNvSpPr/>
            <p:nvPr/>
          </p:nvSpPr>
          <p:spPr>
            <a:xfrm>
              <a:off x="618870" y="5112742"/>
              <a:ext cx="1435008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on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inorganic</a:t>
              </a:r>
            </a:p>
            <a:p>
              <a:pPr algn="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at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port </a:t>
              </a:r>
              <a:endParaRPr lang="es-ES_tradn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8" name="Straight Connector 77"/>
            <p:cNvCxnSpPr/>
            <p:nvPr/>
          </p:nvCxnSpPr>
          <p:spPr>
            <a:xfrm>
              <a:off x="2051720" y="4981951"/>
              <a:ext cx="0" cy="68695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Group 70"/>
          <p:cNvGrpSpPr/>
          <p:nvPr/>
        </p:nvGrpSpPr>
        <p:grpSpPr>
          <a:xfrm>
            <a:off x="4859971" y="1756457"/>
            <a:ext cx="3693632" cy="720932"/>
            <a:chOff x="1009509" y="5862602"/>
            <a:chExt cx="3693632" cy="720932"/>
          </a:xfrm>
        </p:grpSpPr>
        <p:grpSp>
          <p:nvGrpSpPr>
            <p:cNvPr id="50" name="Group 49"/>
            <p:cNvGrpSpPr/>
            <p:nvPr/>
          </p:nvGrpSpPr>
          <p:grpSpPr>
            <a:xfrm>
              <a:off x="2121531" y="5862602"/>
              <a:ext cx="2581610" cy="400110"/>
              <a:chOff x="2121531" y="5818152"/>
              <a:chExt cx="2581610" cy="400110"/>
            </a:xfrm>
          </p:grpSpPr>
          <p:sp>
            <p:nvSpPr>
              <p:cNvPr id="73" name="TextBox 1"/>
              <p:cNvSpPr txBox="1"/>
              <p:nvPr/>
            </p:nvSpPr>
            <p:spPr>
              <a:xfrm>
                <a:off x="3580718" y="5818152"/>
                <a:ext cx="112242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11</a:t>
                </a:r>
                <a:r>
                  <a:rPr lang="es-ES" sz="10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, 0.3)/</a:t>
                </a:r>
              </a:p>
              <a:p>
                <a:r>
                  <a:rPr lang="es-ES" sz="1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12 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.3</a:t>
                </a:r>
                <a:r>
                  <a:rPr lang="es-E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)</a:t>
                </a:r>
                <a:endParaRPr lang="es-ES_tradnl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9" name="Group 28"/>
              <p:cNvGrpSpPr/>
              <p:nvPr/>
            </p:nvGrpSpPr>
            <p:grpSpPr>
              <a:xfrm>
                <a:off x="2121531" y="5854134"/>
                <a:ext cx="1461407" cy="311170"/>
                <a:chOff x="5220072" y="4568095"/>
                <a:chExt cx="1461407" cy="311170"/>
              </a:xfrm>
            </p:grpSpPr>
            <p:pic>
              <p:nvPicPr>
                <p:cNvPr id="1034" name="Picture 10"/>
                <p:cNvPicPr>
                  <a:picLocks noChangeAspect="1" noChangeArrowheads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20" b="16837"/>
                <a:stretch/>
              </p:blipFill>
              <p:spPr bwMode="auto">
                <a:xfrm>
                  <a:off x="5222044" y="4570535"/>
                  <a:ext cx="1459435" cy="3087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5" name="Rectangle 74"/>
                <p:cNvSpPr/>
                <p:nvPr/>
              </p:nvSpPr>
              <p:spPr>
                <a:xfrm>
                  <a:off x="5220072" y="4568095"/>
                  <a:ext cx="1449745" cy="301065"/>
                </a:xfrm>
                <a:prstGeom prst="rect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_tradnl"/>
                </a:p>
              </p:txBody>
            </p:sp>
          </p:grpSp>
        </p:grpSp>
        <p:grpSp>
          <p:nvGrpSpPr>
            <p:cNvPr id="63" name="Group 62"/>
            <p:cNvGrpSpPr/>
            <p:nvPr/>
          </p:nvGrpSpPr>
          <p:grpSpPr>
            <a:xfrm>
              <a:off x="2120774" y="6262712"/>
              <a:ext cx="2476569" cy="301065"/>
              <a:chOff x="2120774" y="6296287"/>
              <a:chExt cx="2476569" cy="301065"/>
            </a:xfrm>
          </p:grpSpPr>
          <p:sp>
            <p:nvSpPr>
              <p:cNvPr id="76" name="TextBox 1"/>
              <p:cNvSpPr txBox="1"/>
              <p:nvPr/>
            </p:nvSpPr>
            <p:spPr>
              <a:xfrm>
                <a:off x="3580718" y="6315670"/>
                <a:ext cx="101662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5</a:t>
                </a:r>
                <a:r>
                  <a:rPr lang="es-ES" sz="10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.4, 0.5)</a:t>
                </a:r>
                <a:endPara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1" name="Group 30"/>
              <p:cNvGrpSpPr/>
              <p:nvPr/>
            </p:nvGrpSpPr>
            <p:grpSpPr>
              <a:xfrm>
                <a:off x="2120774" y="6296287"/>
                <a:ext cx="1449745" cy="301065"/>
                <a:chOff x="5220072" y="4941168"/>
                <a:chExt cx="1449745" cy="301065"/>
              </a:xfrm>
            </p:grpSpPr>
            <p:pic>
              <p:nvPicPr>
                <p:cNvPr id="43" name="Picture 8"/>
                <p:cNvPicPr>
                  <a:picLocks noChangeAspect="1" noChangeArrowheads="1"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18" t="17540" b="16819"/>
                <a:stretch/>
              </p:blipFill>
              <p:spPr bwMode="auto">
                <a:xfrm>
                  <a:off x="5229866" y="4949660"/>
                  <a:ext cx="1423487" cy="29257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7" name="Rectangle 76"/>
                <p:cNvSpPr/>
                <p:nvPr/>
              </p:nvSpPr>
              <p:spPr>
                <a:xfrm>
                  <a:off x="5220072" y="4941168"/>
                  <a:ext cx="1449745" cy="301065"/>
                </a:xfrm>
                <a:prstGeom prst="rect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_tradnl"/>
                </a:p>
              </p:txBody>
            </p:sp>
          </p:grpSp>
        </p:grpSp>
        <p:sp>
          <p:nvSpPr>
            <p:cNvPr id="70" name="Rectangle 69"/>
            <p:cNvSpPr/>
            <p:nvPr/>
          </p:nvSpPr>
          <p:spPr>
            <a:xfrm>
              <a:off x="1009509" y="5998021"/>
              <a:ext cx="103586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creted acid</a:t>
              </a:r>
            </a:p>
            <a:p>
              <a:pPr algn="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atases </a:t>
              </a:r>
              <a:endParaRPr lang="es-ES_tradn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9" name="Straight Connector 78"/>
            <p:cNvCxnSpPr/>
            <p:nvPr/>
          </p:nvCxnSpPr>
          <p:spPr>
            <a:xfrm>
              <a:off x="2051720" y="5896580"/>
              <a:ext cx="0" cy="68695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Group 89"/>
          <p:cNvGrpSpPr/>
          <p:nvPr/>
        </p:nvGrpSpPr>
        <p:grpSpPr>
          <a:xfrm>
            <a:off x="5974732" y="836712"/>
            <a:ext cx="1368080" cy="1006378"/>
            <a:chOff x="2123728" y="1814627"/>
            <a:chExt cx="1368080" cy="1006378"/>
          </a:xfrm>
        </p:grpSpPr>
        <p:sp>
          <p:nvSpPr>
            <p:cNvPr id="91" name="TextBox 90"/>
            <p:cNvSpPr txBox="1"/>
            <p:nvPr/>
          </p:nvSpPr>
          <p:spPr>
            <a:xfrm rot="16200000">
              <a:off x="2147232" y="2505373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QuadreDeText 7"/>
            <p:cNvSpPr txBox="1"/>
            <p:nvPr/>
          </p:nvSpPr>
          <p:spPr>
            <a:xfrm rot="16200000">
              <a:off x="2426859" y="2445866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P8</a:t>
              </a:r>
              <a:endParaRPr lang="ca-E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 rot="16200000">
              <a:off x="2815169" y="2505373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QuadreDeText 7"/>
            <p:cNvSpPr txBox="1"/>
            <p:nvPr/>
          </p:nvSpPr>
          <p:spPr>
            <a:xfrm rot="16200000">
              <a:off x="3094796" y="2445866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P8</a:t>
              </a:r>
              <a:endParaRPr lang="ca-E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5" name="Straight Connector 94"/>
            <p:cNvCxnSpPr/>
            <p:nvPr/>
          </p:nvCxnSpPr>
          <p:spPr>
            <a:xfrm>
              <a:off x="2123728" y="2348880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>
              <a:off x="2843808" y="2348880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1"/>
            <p:cNvSpPr txBox="1"/>
            <p:nvPr/>
          </p:nvSpPr>
          <p:spPr>
            <a:xfrm>
              <a:off x="2282946" y="1814627"/>
              <a:ext cx="11144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X (100 </a:t>
              </a:r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/>
                </a:rPr>
                <a:t></a:t>
              </a:r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/ml)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TextBox 1"/>
            <p:cNvSpPr txBox="1"/>
            <p:nvPr/>
          </p:nvSpPr>
          <p:spPr>
            <a:xfrm>
              <a:off x="2289262" y="2102659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h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TextBox 1"/>
            <p:cNvSpPr txBox="1"/>
            <p:nvPr/>
          </p:nvSpPr>
          <p:spPr>
            <a:xfrm>
              <a:off x="2977048" y="2102659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0" name="Straight Connector 99"/>
            <p:cNvCxnSpPr/>
            <p:nvPr/>
          </p:nvCxnSpPr>
          <p:spPr>
            <a:xfrm>
              <a:off x="2123728" y="2060848"/>
              <a:ext cx="1368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5" name="Rectangle 114"/>
          <p:cNvSpPr/>
          <p:nvPr/>
        </p:nvSpPr>
        <p:spPr>
          <a:xfrm>
            <a:off x="5181188" y="2661386"/>
            <a:ext cx="72327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ess</a:t>
            </a:r>
          </a:p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onse</a:t>
            </a:r>
            <a:endParaRPr lang="es-ES_trad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6" name="Straight Connector 115"/>
          <p:cNvCxnSpPr/>
          <p:nvPr/>
        </p:nvCxnSpPr>
        <p:spPr>
          <a:xfrm>
            <a:off x="5902724" y="2570840"/>
            <a:ext cx="0" cy="6482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4" name="Group 83"/>
          <p:cNvGrpSpPr/>
          <p:nvPr/>
        </p:nvGrpSpPr>
        <p:grpSpPr>
          <a:xfrm>
            <a:off x="5966866" y="3363912"/>
            <a:ext cx="1462953" cy="323800"/>
            <a:chOff x="5966927" y="4348274"/>
            <a:chExt cx="1462953" cy="3238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6952"/>
            <a:stretch/>
          </p:blipFill>
          <p:spPr bwMode="auto">
            <a:xfrm>
              <a:off x="5966927" y="4348274"/>
              <a:ext cx="1460616" cy="323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1" name="Rectangle 130"/>
            <p:cNvSpPr/>
            <p:nvPr/>
          </p:nvSpPr>
          <p:spPr>
            <a:xfrm>
              <a:off x="5980135" y="4352071"/>
              <a:ext cx="1449745" cy="30106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</p:grpSp>
      <p:sp>
        <p:nvSpPr>
          <p:cNvPr id="102" name="TextBox 101"/>
          <p:cNvSpPr txBox="1"/>
          <p:nvPr/>
        </p:nvSpPr>
        <p:spPr>
          <a:xfrm>
            <a:off x="3963124" y="6444044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s-ES_trad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9865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4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A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o Casamayor</dc:creator>
  <cp:lastModifiedBy>Antonio Casamayor</cp:lastModifiedBy>
  <cp:revision>1</cp:revision>
  <dcterms:created xsi:type="dcterms:W3CDTF">2015-06-25T10:32:05Z</dcterms:created>
  <dcterms:modified xsi:type="dcterms:W3CDTF">2015-06-25T10:33:06Z</dcterms:modified>
</cp:coreProperties>
</file>